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0" r:id="rId2"/>
    <p:sldId id="322" r:id="rId3"/>
    <p:sldId id="325" r:id="rId4"/>
    <p:sldId id="319" r:id="rId5"/>
    <p:sldId id="317" r:id="rId6"/>
    <p:sldId id="321" r:id="rId7"/>
    <p:sldId id="32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65"/>
    <p:restoredTop sz="96327"/>
  </p:normalViewPr>
  <p:slideViewPr>
    <p:cSldViewPr snapToGrid="0" snapToObjects="1">
      <p:cViewPr varScale="1">
        <p:scale>
          <a:sx n="118" d="100"/>
          <a:sy n="118" d="100"/>
        </p:scale>
        <p:origin x="224" y="2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7A362C-3460-4D2C-AF3F-6CBF239248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71A10D-40AE-2102-57D3-0DB24D37D3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66D28-85EC-959C-8122-CE584E559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1C97F-86B6-3628-951D-936EADC95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4B4052-261B-BCCD-74DE-9CD5184B5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934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15CDB-9CBE-CBBC-1E17-D5B0E6838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2E01B6-E0BF-B045-418B-565335A6E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5DB27-2642-BC08-0B69-064B3FB6C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DC35B4-CECD-9C80-8614-C5AC65BF1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69F2F-7176-6369-B971-EBAC880A1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892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9FA740-1373-200A-3F4E-231D3335B0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0538A0-8008-4F1A-4F65-DD97314F3E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4BA3BF-2758-8D89-0E50-453044192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F6B0B6-39DE-7BBF-597D-4ADBB3216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CC35A-D056-47AF-9CC3-A5DDB0AE7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946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3AA30-4AF2-8C0B-E461-1357CFEAC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E2AE5F-5D91-0B8E-0D0F-B774A2FC85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21F79-5767-941F-8D60-281DDA3DA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96D312-BA1F-AEC4-FCF7-101B0DA7F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B2DC6-3131-16D1-8775-3E7367B83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552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5D19A2-CCEA-CD56-2F5C-057604D2D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86173E-2420-E0F3-28A8-C26F2DE8E9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BC2927-7510-5ECF-FB63-C57C5EB81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2EDEE-869D-E40A-77D3-C23FF3C88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0DB530-E3EB-4A51-A7AE-9886C6C3B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79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0E0CB0-BDBE-6139-6790-AF5F48D43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CA6E-29F5-7AEB-3C63-C3B05A5B66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9601DF-6935-79E5-58F3-CC69AB3817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7FF4DE-28C2-8682-5F95-0F7610328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6CB0CE-3E29-86E3-31C8-2E4A54395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768C7F-DE96-F113-AF52-39A0F5753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254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21DE9-AEB1-96CE-A03E-800E98ABB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5E4B-3BCF-F8F1-B7E7-728D17DCAB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F020E8-8F1C-36E9-B918-20145A68F0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052189-6223-ED48-B82C-84875B7407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3E30D9-AFA2-518A-32B2-B67BF1B60D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9017E7-E9D9-10A3-7864-A528229EF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262DA9-3DBA-9529-E290-4A9E1D47C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087939-4239-6150-6EF8-02826FF98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110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47430-377A-C675-42FB-3BF240013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CFBC95-0690-2D70-8B6F-C438F8D1B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2FB09D-6A52-E19F-1D0A-9E7ACD0A7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222482-D0CD-8FF0-B553-A81489C04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345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D3A119-5225-537A-7D71-A0138E3F7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CCAC687-5C49-4DD2-4229-D17171F28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7FDE20-0FC8-2681-579B-162649C08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240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A44601-D5AD-3D5F-F06B-AEB228FAF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414125-F981-18DE-B33A-527C84AB7E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65FFD0-9FAF-E9AA-352E-2FE79A4B36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11A6C8-4BAE-1C30-C433-4296C95F4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AE969B-95B3-D3AF-4A8C-05296900F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51DC20-F008-1330-F6FF-7E6EDEA68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664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4C78F7-DE36-7CF6-7378-69E387DA2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6D3398-8B76-27A5-9B36-2DC49789C1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8C3FE0-376D-F014-127A-96F3A37818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E545A2-EFA1-88EE-F831-4B59C97A2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2A9CB7-15DD-461D-84D4-DFC2D6056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D82412-3000-4413-76B4-72C485676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970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EBC0B7-A003-6448-EE66-4A0F411A11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68EE6B-D493-6856-C25E-334D452690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38A49-2088-B473-09F2-4CDB79F9F2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7BA79-3581-E74B-829E-57A4DD9BED07}" type="datetimeFigureOut">
              <a:rPr lang="en-US" smtClean="0"/>
              <a:t>5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D47434-7AA0-E5BE-494F-FDE3C25B27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EB523A-9A6A-060D-5CE4-53DEFED80E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FF538-A432-224E-90C2-6D45DC624B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947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2BAF021C-7707-6CC3-F107-DA2C39DE4C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486"/>
          <a:stretch/>
        </p:blipFill>
        <p:spPr>
          <a:xfrm>
            <a:off x="190801" y="619252"/>
            <a:ext cx="5614058" cy="4603801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3A877EE7-2972-95EC-9CE2-40E689FD479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465"/>
          <a:stretch/>
        </p:blipFill>
        <p:spPr>
          <a:xfrm>
            <a:off x="6387143" y="610557"/>
            <a:ext cx="5459084" cy="461249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B87DE88-F15E-AFFC-CA56-D50F184C4135}"/>
              </a:ext>
            </a:extLst>
          </p:cNvPr>
          <p:cNvSpPr txBox="1"/>
          <p:nvPr/>
        </p:nvSpPr>
        <p:spPr>
          <a:xfrm>
            <a:off x="326073" y="5861974"/>
            <a:ext cx="1013737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1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Dot plot showing means +/- SEM of inflammation and atrophy scores at P60 for experimental groups shown in Figure 2.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9761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0A8EA1EF-068C-E54F-68F7-1E3A00C4A77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983"/>
          <a:stretch/>
        </p:blipFill>
        <p:spPr>
          <a:xfrm>
            <a:off x="939305" y="592810"/>
            <a:ext cx="4178808" cy="4152600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88134D60-D528-F091-A9C3-A5E7806F35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005"/>
          <a:stretch/>
        </p:blipFill>
        <p:spPr>
          <a:xfrm>
            <a:off x="6293292" y="601954"/>
            <a:ext cx="4315968" cy="414345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0C6C0F2-C852-1231-2BEC-5FB3AA15967B}"/>
              </a:ext>
            </a:extLst>
          </p:cNvPr>
          <p:cNvSpPr txBox="1"/>
          <p:nvPr/>
        </p:nvSpPr>
        <p:spPr>
          <a:xfrm>
            <a:off x="478970" y="5569020"/>
            <a:ext cx="1063534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2. 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ot plot showing means +/- SEM of inflammation and atrophy scores at P60 for experimental groups shown in Figure 4.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8427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E997980-246B-F0BB-F3E3-0085D691DB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5573"/>
          <a:stretch/>
        </p:blipFill>
        <p:spPr>
          <a:xfrm>
            <a:off x="345515" y="514023"/>
            <a:ext cx="8979189" cy="212758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97C5030-ED1C-0DBB-264E-F2476602A0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5878"/>
          <a:stretch/>
        </p:blipFill>
        <p:spPr>
          <a:xfrm>
            <a:off x="323159" y="3081096"/>
            <a:ext cx="8979189" cy="212758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53B4AE7-8ABF-953A-86A2-42447B737F0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4705" b="16398"/>
          <a:stretch/>
        </p:blipFill>
        <p:spPr>
          <a:xfrm>
            <a:off x="9251697" y="514023"/>
            <a:ext cx="2271313" cy="212758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B013D65-03E3-2C11-CEA2-395A5CD925F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05" b="19149"/>
          <a:stretch/>
        </p:blipFill>
        <p:spPr>
          <a:xfrm>
            <a:off x="9236246" y="3121840"/>
            <a:ext cx="2271312" cy="20461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D551550-CA7F-F092-2816-AA3C8EAB2905}"/>
              </a:ext>
            </a:extLst>
          </p:cNvPr>
          <p:cNvSpPr txBox="1"/>
          <p:nvPr/>
        </p:nvSpPr>
        <p:spPr>
          <a:xfrm>
            <a:off x="143220" y="100868"/>
            <a:ext cx="14903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2000" b="1" dirty="0"/>
              <a:t>Lymph nod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ED1AA82-93AC-DDA6-BB6D-41F97B57372F}"/>
              </a:ext>
            </a:extLst>
          </p:cNvPr>
          <p:cNvSpPr txBox="1"/>
          <p:nvPr/>
        </p:nvSpPr>
        <p:spPr>
          <a:xfrm>
            <a:off x="261053" y="2676687"/>
            <a:ext cx="8684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2000" b="1" dirty="0"/>
              <a:t>Reti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C17A78C-95F9-9B6B-E317-B590CE3D6EBB}"/>
              </a:ext>
            </a:extLst>
          </p:cNvPr>
          <p:cNvSpPr txBox="1"/>
          <p:nvPr/>
        </p:nvSpPr>
        <p:spPr>
          <a:xfrm>
            <a:off x="489857" y="5688913"/>
            <a:ext cx="1121228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3. 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Gating strategy for flow cytometry analysis of lymph node and retina cells after treatment with DEC205-HEL fusion protein and PBS. This gating strategy was applied on the data presented in Figure 6.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2078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BC8A145-D61F-094C-1B92-781BBFD975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172572"/>
              </p:ext>
            </p:extLst>
          </p:nvPr>
        </p:nvGraphicFramePr>
        <p:xfrm>
          <a:off x="667451" y="1157460"/>
          <a:ext cx="10900741" cy="332486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09378">
                  <a:extLst>
                    <a:ext uri="{9D8B030D-6E8A-4147-A177-3AD203B41FA5}">
                      <a16:colId xmlns:a16="http://schemas.microsoft.com/office/drawing/2014/main" val="1247814765"/>
                    </a:ext>
                  </a:extLst>
                </a:gridCol>
                <a:gridCol w="1670695">
                  <a:extLst>
                    <a:ext uri="{9D8B030D-6E8A-4147-A177-3AD203B41FA5}">
                      <a16:colId xmlns:a16="http://schemas.microsoft.com/office/drawing/2014/main" val="354423696"/>
                    </a:ext>
                  </a:extLst>
                </a:gridCol>
                <a:gridCol w="1775114">
                  <a:extLst>
                    <a:ext uri="{9D8B030D-6E8A-4147-A177-3AD203B41FA5}">
                      <a16:colId xmlns:a16="http://schemas.microsoft.com/office/drawing/2014/main" val="1724260720"/>
                    </a:ext>
                  </a:extLst>
                </a:gridCol>
                <a:gridCol w="1635889">
                  <a:extLst>
                    <a:ext uri="{9D8B030D-6E8A-4147-A177-3AD203B41FA5}">
                      <a16:colId xmlns:a16="http://schemas.microsoft.com/office/drawing/2014/main" val="2515547551"/>
                    </a:ext>
                  </a:extLst>
                </a:gridCol>
                <a:gridCol w="1722904">
                  <a:extLst>
                    <a:ext uri="{9D8B030D-6E8A-4147-A177-3AD203B41FA5}">
                      <a16:colId xmlns:a16="http://schemas.microsoft.com/office/drawing/2014/main" val="2034246522"/>
                    </a:ext>
                  </a:extLst>
                </a:gridCol>
                <a:gridCol w="1443619">
                  <a:extLst>
                    <a:ext uri="{9D8B030D-6E8A-4147-A177-3AD203B41FA5}">
                      <a16:colId xmlns:a16="http://schemas.microsoft.com/office/drawing/2014/main" val="3910424073"/>
                    </a:ext>
                  </a:extLst>
                </a:gridCol>
                <a:gridCol w="1643142">
                  <a:extLst>
                    <a:ext uri="{9D8B030D-6E8A-4147-A177-3AD203B41FA5}">
                      <a16:colId xmlns:a16="http://schemas.microsoft.com/office/drawing/2014/main" val="4105226146"/>
                    </a:ext>
                  </a:extLst>
                </a:gridCol>
              </a:tblGrid>
              <a:tr h="277495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inflammation)</a:t>
                      </a:r>
                    </a:p>
                  </a:txBody>
                  <a:tcPr marL="6350" marR="6350" marT="635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Isotype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OVA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i.p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1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12807565"/>
                  </a:ext>
                </a:extLst>
              </a:tr>
              <a:tr h="2774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BS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Isotype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OVA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i.p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1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1139798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2.5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399401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288071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324020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2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42446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319951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477340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8023252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0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 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5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0014792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D3FCE77-E87F-ADA8-42E0-88DD01536D00}"/>
              </a:ext>
            </a:extLst>
          </p:cNvPr>
          <p:cNvSpPr txBox="1"/>
          <p:nvPr/>
        </p:nvSpPr>
        <p:spPr>
          <a:xfrm>
            <a:off x="667451" y="5159344"/>
            <a:ext cx="1019991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upplementary Table 1A. </a:t>
            </a:r>
            <a:r>
              <a:rPr lang="en-US" sz="20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ata for inflammation scores at P60 for experimental groups displayed in Figure 2.</a:t>
            </a:r>
            <a:r>
              <a:rPr lang="en-CN" sz="2000" dirty="0">
                <a:effectLst/>
              </a:rPr>
              <a:t> </a:t>
            </a:r>
            <a:endParaRPr lang="en-CN" sz="2000" dirty="0"/>
          </a:p>
        </p:txBody>
      </p:sp>
    </p:spTree>
    <p:extLst>
      <p:ext uri="{BB962C8B-B14F-4D97-AF65-F5344CB8AC3E}">
        <p14:creationId xmlns:p14="http://schemas.microsoft.com/office/powerpoint/2010/main" val="4860744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F604243-29D3-61BC-CEEF-231E3899A7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0060213"/>
              </p:ext>
            </p:extLst>
          </p:nvPr>
        </p:nvGraphicFramePr>
        <p:xfrm>
          <a:off x="576282" y="1107206"/>
          <a:ext cx="11039436" cy="332486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65218">
                  <a:extLst>
                    <a:ext uri="{9D8B030D-6E8A-4147-A177-3AD203B41FA5}">
                      <a16:colId xmlns:a16="http://schemas.microsoft.com/office/drawing/2014/main" val="624766428"/>
                    </a:ext>
                  </a:extLst>
                </a:gridCol>
                <a:gridCol w="1577968">
                  <a:extLst>
                    <a:ext uri="{9D8B030D-6E8A-4147-A177-3AD203B41FA5}">
                      <a16:colId xmlns:a16="http://schemas.microsoft.com/office/drawing/2014/main" val="778768642"/>
                    </a:ext>
                  </a:extLst>
                </a:gridCol>
                <a:gridCol w="1657350">
                  <a:extLst>
                    <a:ext uri="{9D8B030D-6E8A-4147-A177-3AD203B41FA5}">
                      <a16:colId xmlns:a16="http://schemas.microsoft.com/office/drawing/2014/main" val="2185773218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49060915"/>
                    </a:ext>
                  </a:extLst>
                </a:gridCol>
                <a:gridCol w="1638300">
                  <a:extLst>
                    <a:ext uri="{9D8B030D-6E8A-4147-A177-3AD203B41FA5}">
                      <a16:colId xmlns:a16="http://schemas.microsoft.com/office/drawing/2014/main" val="680579712"/>
                    </a:ext>
                  </a:extLst>
                </a:gridCol>
                <a:gridCol w="1657350">
                  <a:extLst>
                    <a:ext uri="{9D8B030D-6E8A-4147-A177-3AD203B41FA5}">
                      <a16:colId xmlns:a16="http://schemas.microsoft.com/office/drawing/2014/main" val="1401256985"/>
                    </a:ext>
                  </a:extLst>
                </a:gridCol>
                <a:gridCol w="1619250">
                  <a:extLst>
                    <a:ext uri="{9D8B030D-6E8A-4147-A177-3AD203B41FA5}">
                      <a16:colId xmlns:a16="http://schemas.microsoft.com/office/drawing/2014/main" val="1954810809"/>
                    </a:ext>
                  </a:extLst>
                </a:gridCol>
              </a:tblGrid>
              <a:tr h="277495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atrophy)</a:t>
                      </a:r>
                    </a:p>
                  </a:txBody>
                  <a:tcPr marL="6350" marR="6350" marT="635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Isotype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OVA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i.p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1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30371260"/>
                  </a:ext>
                </a:extLst>
              </a:tr>
              <a:tr h="2774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BS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Isotype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OVA (x6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6) </a:t>
                      </a:r>
                      <a:r>
                        <a:rPr lang="en-GB" sz="1800" b="1" u="none" strike="noStrike" dirty="0" err="1">
                          <a:effectLst/>
                        </a:rPr>
                        <a:t>i.p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1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369302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34110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775748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2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4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059274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57899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5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696634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5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 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227338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4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3.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548773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2.75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1.0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3.50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>
                          <a:effectLst/>
                        </a:rPr>
                        <a:t> </a:t>
                      </a:r>
                      <a:endParaRPr lang="en-GB" sz="2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000" b="0" u="none" strike="noStrike" dirty="0">
                          <a:effectLst/>
                        </a:rPr>
                        <a:t>2.0</a:t>
                      </a:r>
                      <a:endParaRPr lang="en-GB" sz="2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37721867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E70E81D-0EFD-B583-2D01-124F7B289882}"/>
              </a:ext>
            </a:extLst>
          </p:cNvPr>
          <p:cNvSpPr txBox="1"/>
          <p:nvPr/>
        </p:nvSpPr>
        <p:spPr>
          <a:xfrm>
            <a:off x="576282" y="5045884"/>
            <a:ext cx="1004751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Table 1B. 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ata for atrophy scores for experimental groups displayed in Figure 2   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94019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C403101-73E4-D353-066C-0DECD1AAD4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0469173"/>
              </p:ext>
            </p:extLst>
          </p:nvPr>
        </p:nvGraphicFramePr>
        <p:xfrm>
          <a:off x="504222" y="914936"/>
          <a:ext cx="5474825" cy="336804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82266">
                  <a:extLst>
                    <a:ext uri="{9D8B030D-6E8A-4147-A177-3AD203B41FA5}">
                      <a16:colId xmlns:a16="http://schemas.microsoft.com/office/drawing/2014/main" val="4048584824"/>
                    </a:ext>
                  </a:extLst>
                </a:gridCol>
                <a:gridCol w="1984326">
                  <a:extLst>
                    <a:ext uri="{9D8B030D-6E8A-4147-A177-3AD203B41FA5}">
                      <a16:colId xmlns:a16="http://schemas.microsoft.com/office/drawing/2014/main" val="4228289274"/>
                    </a:ext>
                  </a:extLst>
                </a:gridCol>
                <a:gridCol w="2008233">
                  <a:extLst>
                    <a:ext uri="{9D8B030D-6E8A-4147-A177-3AD203B41FA5}">
                      <a16:colId xmlns:a16="http://schemas.microsoft.com/office/drawing/2014/main" val="1867552347"/>
                    </a:ext>
                  </a:extLst>
                </a:gridCol>
              </a:tblGrid>
              <a:tr h="14033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inflammation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70976957"/>
                  </a:ext>
                </a:extLst>
              </a:tr>
              <a:tr h="14033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BS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04565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2.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5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732522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1.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380494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2.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0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89342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0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88101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2.5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412904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1.5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5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490179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251804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2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4479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 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31989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4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 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2478381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48EB3D9-616B-FDC8-6054-DF7F4FE21D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916658"/>
              </p:ext>
            </p:extLst>
          </p:nvPr>
        </p:nvGraphicFramePr>
        <p:xfrm>
          <a:off x="6198966" y="914936"/>
          <a:ext cx="5474826" cy="336804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94338">
                  <a:extLst>
                    <a:ext uri="{9D8B030D-6E8A-4147-A177-3AD203B41FA5}">
                      <a16:colId xmlns:a16="http://schemas.microsoft.com/office/drawing/2014/main" val="502542247"/>
                    </a:ext>
                  </a:extLst>
                </a:gridCol>
                <a:gridCol w="2066493">
                  <a:extLst>
                    <a:ext uri="{9D8B030D-6E8A-4147-A177-3AD203B41FA5}">
                      <a16:colId xmlns:a16="http://schemas.microsoft.com/office/drawing/2014/main" val="1711583534"/>
                    </a:ext>
                  </a:extLst>
                </a:gridCol>
                <a:gridCol w="2013995">
                  <a:extLst>
                    <a:ext uri="{9D8B030D-6E8A-4147-A177-3AD203B41FA5}">
                      <a16:colId xmlns:a16="http://schemas.microsoft.com/office/drawing/2014/main" val="2922678729"/>
                    </a:ext>
                  </a:extLst>
                </a:gridCol>
              </a:tblGrid>
              <a:tr h="14033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atrophy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603384960"/>
                  </a:ext>
                </a:extLst>
              </a:tr>
              <a:tr h="14033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BS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EC205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DCIR2-HEL (x5) </a:t>
                      </a:r>
                      <a:r>
                        <a:rPr lang="en-GB" sz="1800" b="1" u="none" strike="noStrike" dirty="0" err="1">
                          <a:effectLst/>
                        </a:rPr>
                        <a:t>s.c.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7757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75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5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080985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75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374482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25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2.5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243741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5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606896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2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92363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2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3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2.75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111616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0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821846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3.50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098676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 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 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940557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4.00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>
                          <a:effectLst/>
                        </a:rPr>
                        <a:t> </a:t>
                      </a:r>
                      <a:endParaRPr lang="en-GB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0" u="none" strike="noStrike" dirty="0">
                          <a:effectLst/>
                        </a:rPr>
                        <a:t> </a:t>
                      </a:r>
                      <a:endParaRPr lang="en-GB" sz="1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0211530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DBB7D0B-A987-1FCB-B965-174DFD3BEC5B}"/>
              </a:ext>
            </a:extLst>
          </p:cNvPr>
          <p:cNvSpPr txBox="1"/>
          <p:nvPr/>
        </p:nvSpPr>
        <p:spPr>
          <a:xfrm>
            <a:off x="504222" y="4989064"/>
            <a:ext cx="1040741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Table 2. 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ata for inflammation and atrophy scores displayed in Figure 3.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7765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C403101-73E4-D353-066C-0DECD1AAD4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4486879"/>
              </p:ext>
            </p:extLst>
          </p:nvPr>
        </p:nvGraphicFramePr>
        <p:xfrm>
          <a:off x="103145" y="1009760"/>
          <a:ext cx="5879013" cy="335026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55010">
                  <a:extLst>
                    <a:ext uri="{9D8B030D-6E8A-4147-A177-3AD203B41FA5}">
                      <a16:colId xmlns:a16="http://schemas.microsoft.com/office/drawing/2014/main" val="4048584824"/>
                    </a:ext>
                  </a:extLst>
                </a:gridCol>
                <a:gridCol w="1174648">
                  <a:extLst>
                    <a:ext uri="{9D8B030D-6E8A-4147-A177-3AD203B41FA5}">
                      <a16:colId xmlns:a16="http://schemas.microsoft.com/office/drawing/2014/main" val="4228289274"/>
                    </a:ext>
                  </a:extLst>
                </a:gridCol>
                <a:gridCol w="1233889">
                  <a:extLst>
                    <a:ext uri="{9D8B030D-6E8A-4147-A177-3AD203B41FA5}">
                      <a16:colId xmlns:a16="http://schemas.microsoft.com/office/drawing/2014/main" val="3947186323"/>
                    </a:ext>
                  </a:extLst>
                </a:gridCol>
                <a:gridCol w="1293442">
                  <a:extLst>
                    <a:ext uri="{9D8B030D-6E8A-4147-A177-3AD203B41FA5}">
                      <a16:colId xmlns:a16="http://schemas.microsoft.com/office/drawing/2014/main" val="65185411"/>
                    </a:ext>
                  </a:extLst>
                </a:gridCol>
                <a:gridCol w="1322024">
                  <a:extLst>
                    <a:ext uri="{9D8B030D-6E8A-4147-A177-3AD203B41FA5}">
                      <a16:colId xmlns:a16="http://schemas.microsoft.com/office/drawing/2014/main" val="1867552347"/>
                    </a:ext>
                  </a:extLst>
                </a:gridCol>
              </a:tblGrid>
              <a:tr h="140335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inflammation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endParaRPr lang="en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70976957"/>
                  </a:ext>
                </a:extLst>
              </a:tr>
              <a:tr h="14033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60 PBS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60 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85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100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115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04565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32522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80494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89342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2.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.1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7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88101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12904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490179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251804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58447981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3F5B5DF-2E3B-F01B-5E12-5B8E6913A9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0895643"/>
              </p:ext>
            </p:extLst>
          </p:nvPr>
        </p:nvGraphicFramePr>
        <p:xfrm>
          <a:off x="6209842" y="1009760"/>
          <a:ext cx="5879013" cy="335026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55010">
                  <a:extLst>
                    <a:ext uri="{9D8B030D-6E8A-4147-A177-3AD203B41FA5}">
                      <a16:colId xmlns:a16="http://schemas.microsoft.com/office/drawing/2014/main" val="4048584824"/>
                    </a:ext>
                  </a:extLst>
                </a:gridCol>
                <a:gridCol w="1174648">
                  <a:extLst>
                    <a:ext uri="{9D8B030D-6E8A-4147-A177-3AD203B41FA5}">
                      <a16:colId xmlns:a16="http://schemas.microsoft.com/office/drawing/2014/main" val="4228289274"/>
                    </a:ext>
                  </a:extLst>
                </a:gridCol>
                <a:gridCol w="1233889">
                  <a:extLst>
                    <a:ext uri="{9D8B030D-6E8A-4147-A177-3AD203B41FA5}">
                      <a16:colId xmlns:a16="http://schemas.microsoft.com/office/drawing/2014/main" val="3947186323"/>
                    </a:ext>
                  </a:extLst>
                </a:gridCol>
                <a:gridCol w="1293442">
                  <a:extLst>
                    <a:ext uri="{9D8B030D-6E8A-4147-A177-3AD203B41FA5}">
                      <a16:colId xmlns:a16="http://schemas.microsoft.com/office/drawing/2014/main" val="65185411"/>
                    </a:ext>
                  </a:extLst>
                </a:gridCol>
                <a:gridCol w="1322024">
                  <a:extLst>
                    <a:ext uri="{9D8B030D-6E8A-4147-A177-3AD203B41FA5}">
                      <a16:colId xmlns:a16="http://schemas.microsoft.com/office/drawing/2014/main" val="1867552347"/>
                    </a:ext>
                  </a:extLst>
                </a:gridCol>
              </a:tblGrid>
              <a:tr h="140335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effectLst/>
                          <a:latin typeface="Arial" panose="020B0604020202020204" pitchFamily="34" charset="0"/>
                        </a:rPr>
                        <a:t>EAU Score (atrophy)</a:t>
                      </a:r>
                    </a:p>
                  </a:txBody>
                  <a:tcPr marL="6350" marR="6350" marT="6350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endParaRPr lang="en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70976957"/>
                  </a:ext>
                </a:extLst>
              </a:tr>
              <a:tr h="14033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60 PBS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800" b="1" u="none" strike="noStrike" dirty="0">
                          <a:effectLst/>
                        </a:rPr>
                        <a:t>P60 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85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100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P115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u="none" strike="noStrike" dirty="0">
                          <a:effectLst/>
                        </a:rPr>
                        <a:t>DEC205-HEL</a:t>
                      </a:r>
                      <a:endParaRPr lang="en-GB" sz="1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04565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2.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.7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32522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0.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89018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0.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80494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893421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88101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>
                          <a:effectLst/>
                          <a:latin typeface="+mn-lt"/>
                        </a:rPr>
                        <a:t>2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12904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490179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N" sz="2000" b="0" i="0" u="none" strike="noStrike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N" sz="2000" b="0" i="0" u="none" strike="noStrike" dirty="0"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2518043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F306C20-BD76-8643-9568-39ADE75889F1}"/>
              </a:ext>
            </a:extLst>
          </p:cNvPr>
          <p:cNvSpPr txBox="1"/>
          <p:nvPr/>
        </p:nvSpPr>
        <p:spPr>
          <a:xfrm>
            <a:off x="696684" y="5127446"/>
            <a:ext cx="978625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0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Table 3. </a:t>
            </a:r>
            <a:r>
              <a:rPr lang="en-US" sz="20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ata for inflammation and atrophy scores displayed in Figure 5.</a:t>
            </a:r>
            <a:endParaRPr lang="en-CN" sz="16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25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36</TotalTime>
  <Words>588</Words>
  <Application>Microsoft Macintosh PowerPoint</Application>
  <PresentationFormat>Widescreen</PresentationFormat>
  <Paragraphs>28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DengXia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rrester, J.V.</dc:creator>
  <cp:lastModifiedBy>Yu, T.</cp:lastModifiedBy>
  <cp:revision>63</cp:revision>
  <dcterms:created xsi:type="dcterms:W3CDTF">2022-05-04T08:49:03Z</dcterms:created>
  <dcterms:modified xsi:type="dcterms:W3CDTF">2023-05-21T13:43:47Z</dcterms:modified>
</cp:coreProperties>
</file>